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fntdata" ContentType="application/x-fontdata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sldIdLst>
    <p:sldId id="257" r:id="rId2"/>
  </p:sldIdLst>
  <p:sldSz cx="12192000" cy="6858000"/>
  <p:notesSz cx="6858000" cy="9144000"/>
  <p:embeddedFontLst>
    <p:embeddedFont>
      <p:font typeface="Calibri" panose="020F0502020204030204" pitchFamily="34" charset="0"/>
      <p:regular r:id="rId3"/>
      <p:bold r:id="rId4"/>
      <p:italic r:id="rId5"/>
      <p:boldItalic r:id="rId6"/>
    </p:embeddedFont>
    <p:embeddedFont>
      <p:font typeface="Calibri Light" panose="020F0302020204030204" pitchFamily="34" charset="0"/>
      <p:regular r:id="rId7"/>
      <p:italic r:id="rId8"/>
    </p:embeddedFont>
  </p:embeddedFontLst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138" y="3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6.fntdata"/><Relationship Id="rId3" Type="http://schemas.openxmlformats.org/officeDocument/2006/relationships/font" Target="fonts/font1.fntdata"/><Relationship Id="rId7" Type="http://schemas.openxmlformats.org/officeDocument/2006/relationships/font" Target="fonts/font5.fntdata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4.fntdata"/><Relationship Id="rId11" Type="http://schemas.openxmlformats.org/officeDocument/2006/relationships/theme" Target="theme/theme1.xml"/><Relationship Id="rId5" Type="http://schemas.openxmlformats.org/officeDocument/2006/relationships/font" Target="fonts/font3.fntdata"/><Relationship Id="rId10" Type="http://schemas.openxmlformats.org/officeDocument/2006/relationships/viewProps" Target="viewProps.xml"/><Relationship Id="rId4" Type="http://schemas.openxmlformats.org/officeDocument/2006/relationships/font" Target="fonts/font2.fntdata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vaccination-onl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Sheet4!$B$18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4!$C$12:$H$12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Sheet4!$C$18:$H$18</c:f>
              <c:numCache>
                <c:formatCode>General</c:formatCode>
                <c:ptCount val="6"/>
                <c:pt idx="0">
                  <c:v>84352.815400000007</c:v>
                </c:pt>
                <c:pt idx="1">
                  <c:v>304188.44799999997</c:v>
                </c:pt>
                <c:pt idx="2">
                  <c:v>313160.72499999998</c:v>
                </c:pt>
                <c:pt idx="3">
                  <c:v>750029.72499999998</c:v>
                </c:pt>
                <c:pt idx="4">
                  <c:v>210683.73420000001</c:v>
                </c:pt>
                <c:pt idx="5">
                  <c:v>237091.18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951-4FD8-BC51-A204A2FDA1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17686504"/>
        <c:axId val="517681256"/>
      </c:lineChart>
      <c:scatterChart>
        <c:scatterStyle val="lineMarker"/>
        <c:varyColors val="0"/>
        <c:ser>
          <c:idx val="0"/>
          <c:order val="0"/>
          <c:tx>
            <c:strRef>
              <c:f>Sheet4!$B$13</c:f>
              <c:strCache>
                <c:ptCount val="1"/>
                <c:pt idx="0">
                  <c:v>6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Sheet4!$C$12:$H$12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4!$C$13:$H$13</c:f>
              <c:numCache>
                <c:formatCode>General</c:formatCode>
                <c:ptCount val="6"/>
                <c:pt idx="0">
                  <c:v>24123.58</c:v>
                </c:pt>
                <c:pt idx="1">
                  <c:v>257976.6</c:v>
                </c:pt>
                <c:pt idx="2">
                  <c:v>177590.47500000001</c:v>
                </c:pt>
                <c:pt idx="3">
                  <c:v>1368935.7000000002</c:v>
                </c:pt>
                <c:pt idx="4">
                  <c:v>141854.30399999997</c:v>
                </c:pt>
                <c:pt idx="5">
                  <c:v>130705.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951-4FD8-BC51-A204A2FDA1A2}"/>
            </c:ext>
          </c:extLst>
        </c:ser>
        <c:ser>
          <c:idx val="1"/>
          <c:order val="1"/>
          <c:tx>
            <c:strRef>
              <c:f>Sheet4!$B$14</c:f>
              <c:strCache>
                <c:ptCount val="1"/>
                <c:pt idx="0">
                  <c:v>7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Sheet4!$C$12:$H$12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4!$C$14:$H$14</c:f>
              <c:numCache>
                <c:formatCode>General</c:formatCode>
                <c:ptCount val="6"/>
                <c:pt idx="0">
                  <c:v>332929.60000000003</c:v>
                </c:pt>
                <c:pt idx="1">
                  <c:v>355957.875</c:v>
                </c:pt>
                <c:pt idx="2">
                  <c:v>390379.5</c:v>
                </c:pt>
                <c:pt idx="3">
                  <c:v>314193.65999999997</c:v>
                </c:pt>
                <c:pt idx="4">
                  <c:v>125340.185</c:v>
                </c:pt>
                <c:pt idx="5">
                  <c:v>105969.6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951-4FD8-BC51-A204A2FDA1A2}"/>
            </c:ext>
          </c:extLst>
        </c:ser>
        <c:ser>
          <c:idx val="2"/>
          <c:order val="2"/>
          <c:tx>
            <c:strRef>
              <c:f>Sheet4!$B$15</c:f>
              <c:strCache>
                <c:ptCount val="1"/>
                <c:pt idx="0">
                  <c:v>8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Sheet4!$C$12:$H$12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4!$C$15:$H$15</c:f>
              <c:numCache>
                <c:formatCode>General</c:formatCode>
                <c:ptCount val="6"/>
                <c:pt idx="0">
                  <c:v>17817.575999999997</c:v>
                </c:pt>
                <c:pt idx="1">
                  <c:v>289564.36500000005</c:v>
                </c:pt>
                <c:pt idx="2">
                  <c:v>177921.90000000002</c:v>
                </c:pt>
                <c:pt idx="3">
                  <c:v>881125.2</c:v>
                </c:pt>
                <c:pt idx="4">
                  <c:v>77312.95</c:v>
                </c:pt>
                <c:pt idx="5">
                  <c:v>474597.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951-4FD8-BC51-A204A2FDA1A2}"/>
            </c:ext>
          </c:extLst>
        </c:ser>
        <c:ser>
          <c:idx val="3"/>
          <c:order val="3"/>
          <c:tx>
            <c:strRef>
              <c:f>Sheet4!$B$16</c:f>
              <c:strCache>
                <c:ptCount val="1"/>
                <c:pt idx="0">
                  <c:v>9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Sheet4!$C$12:$H$12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4!$C$16:$H$16</c:f>
              <c:numCache>
                <c:formatCode>General</c:formatCode>
                <c:ptCount val="6"/>
                <c:pt idx="0">
                  <c:v>8674.4969999999994</c:v>
                </c:pt>
                <c:pt idx="1">
                  <c:v>368995.2</c:v>
                </c:pt>
                <c:pt idx="2">
                  <c:v>303063.11</c:v>
                </c:pt>
                <c:pt idx="3">
                  <c:v>550690.14</c:v>
                </c:pt>
                <c:pt idx="4">
                  <c:v>502804.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1951-4FD8-BC51-A204A2FDA1A2}"/>
            </c:ext>
          </c:extLst>
        </c:ser>
        <c:ser>
          <c:idx val="4"/>
          <c:order val="4"/>
          <c:tx>
            <c:strRef>
              <c:f>Sheet4!$B$17</c:f>
              <c:strCache>
                <c:ptCount val="1"/>
                <c:pt idx="0">
                  <c:v>1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Sheet4!$C$12:$H$12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4!$C$17:$H$17</c:f>
              <c:numCache>
                <c:formatCode>General</c:formatCode>
                <c:ptCount val="6"/>
                <c:pt idx="0">
                  <c:v>38218.824000000001</c:v>
                </c:pt>
                <c:pt idx="1">
                  <c:v>248448.2</c:v>
                </c:pt>
                <c:pt idx="2">
                  <c:v>516848.64000000001</c:v>
                </c:pt>
                <c:pt idx="3">
                  <c:v>635203.92500000005</c:v>
                </c:pt>
                <c:pt idx="4">
                  <c:v>206106.912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1951-4FD8-BC51-A204A2FDA1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6492656"/>
        <c:axId val="525994416"/>
      </c:scatterChart>
      <c:catAx>
        <c:axId val="517686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17681256"/>
        <c:crosses val="autoZero"/>
        <c:auto val="1"/>
        <c:lblAlgn val="ctr"/>
        <c:lblOffset val="100"/>
        <c:noMultiLvlLbl val="0"/>
      </c:catAx>
      <c:valAx>
        <c:axId val="517681256"/>
        <c:scaling>
          <c:orientation val="minMax"/>
          <c:max val="16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17686504"/>
        <c:crosses val="autoZero"/>
        <c:crossBetween val="between"/>
        <c:majorUnit val="400000"/>
        <c:dispUnits>
          <c:builtInUnit val="hundredThousands"/>
          <c:dispUnitsLbl>
            <c:layout>
              <c:manualLayout>
                <c:xMode val="edge"/>
                <c:yMode val="edge"/>
                <c:x val="2.6061487948660547E-2"/>
                <c:y val="0.38130299931833672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>
                      <a:effectLst/>
                    </a:rPr>
                    <a:t>10</a:t>
                  </a:r>
                  <a:r>
                    <a:rPr lang="de-AT" sz="1000" b="0" baseline="30000">
                      <a:effectLst/>
                    </a:rPr>
                    <a:t>5 </a:t>
                  </a:r>
                  <a:r>
                    <a:rPr lang="de-AT" sz="1000" b="0" i="0" u="none" strike="noStrike" baseline="0">
                      <a:effectLst/>
                    </a:rPr>
                    <a:t>cells</a:t>
                  </a:r>
                  <a:r>
                    <a:rPr lang="de-AT" sz="1000" b="0">
                      <a:effectLst/>
                    </a:rPr>
                    <a:t>/ml</a:t>
                  </a: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525994416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526492656"/>
        <c:crosses val="max"/>
        <c:crossBetween val="midCat"/>
      </c:valAx>
      <c:valAx>
        <c:axId val="526492656"/>
        <c:scaling>
          <c:orientation val="minMax"/>
        </c:scaling>
        <c:delete val="1"/>
        <c:axPos val="t"/>
        <c:majorTickMark val="out"/>
        <c:minorTickMark val="none"/>
        <c:tickLblPos val="nextTo"/>
        <c:crossAx val="525994416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negative control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Sheet4!$B$9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4!$C$3:$H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Sheet4!$C$9:$H$9</c:f>
              <c:numCache>
                <c:formatCode>General</c:formatCode>
                <c:ptCount val="6"/>
                <c:pt idx="0">
                  <c:v>159321.45569999999</c:v>
                </c:pt>
                <c:pt idx="1">
                  <c:v>268897.79720000003</c:v>
                </c:pt>
                <c:pt idx="2">
                  <c:v>564352.64199999999</c:v>
                </c:pt>
                <c:pt idx="3">
                  <c:v>514104.94230000005</c:v>
                </c:pt>
                <c:pt idx="4">
                  <c:v>438739.75159999996</c:v>
                </c:pt>
                <c:pt idx="5">
                  <c:v>393586.1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9BE-484A-93AB-304FAACA27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45692400"/>
        <c:axId val="445686496"/>
      </c:lineChart>
      <c:scatterChart>
        <c:scatterStyle val="lineMarker"/>
        <c:varyColors val="0"/>
        <c:ser>
          <c:idx val="0"/>
          <c:order val="0"/>
          <c:tx>
            <c:strRef>
              <c:f>Sheet4!$B$4</c:f>
              <c:strCache>
                <c:ptCount val="1"/>
                <c:pt idx="0">
                  <c:v>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Sheet4!$C$3:$H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4!$C$4:$H$4</c:f>
              <c:numCache>
                <c:formatCode>General</c:formatCode>
                <c:ptCount val="6"/>
                <c:pt idx="0">
                  <c:v>292076.40000000002</c:v>
                </c:pt>
                <c:pt idx="1">
                  <c:v>304013.77</c:v>
                </c:pt>
                <c:pt idx="2">
                  <c:v>418192.21</c:v>
                </c:pt>
                <c:pt idx="3">
                  <c:v>447405.13200000004</c:v>
                </c:pt>
                <c:pt idx="4">
                  <c:v>546740.29</c:v>
                </c:pt>
                <c:pt idx="5">
                  <c:v>360923.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9BE-484A-93AB-304FAACA27B8}"/>
            </c:ext>
          </c:extLst>
        </c:ser>
        <c:ser>
          <c:idx val="1"/>
          <c:order val="1"/>
          <c:tx>
            <c:strRef>
              <c:f>Sheet4!$B$5</c:f>
              <c:strCache>
                <c:ptCount val="1"/>
                <c:pt idx="0">
                  <c:v>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Sheet4!$C$3:$H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4!$C$5:$H$5</c:f>
              <c:numCache>
                <c:formatCode>General</c:formatCode>
                <c:ptCount val="6"/>
                <c:pt idx="0">
                  <c:v>126708.78000000001</c:v>
                </c:pt>
                <c:pt idx="1">
                  <c:v>332563.96799999999</c:v>
                </c:pt>
                <c:pt idx="2">
                  <c:v>368339.4</c:v>
                </c:pt>
                <c:pt idx="3">
                  <c:v>714767.50799999991</c:v>
                </c:pt>
                <c:pt idx="4">
                  <c:v>448242.5</c:v>
                </c:pt>
                <c:pt idx="5">
                  <c:v>530776.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9BE-484A-93AB-304FAACA27B8}"/>
            </c:ext>
          </c:extLst>
        </c:ser>
        <c:ser>
          <c:idx val="2"/>
          <c:order val="2"/>
          <c:tx>
            <c:strRef>
              <c:f>Sheet4!$B$6</c:f>
              <c:strCache>
                <c:ptCount val="1"/>
                <c:pt idx="0">
                  <c:v>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Sheet4!$C$3:$H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4!$C$6:$H$6</c:f>
              <c:numCache>
                <c:formatCode>General</c:formatCode>
                <c:ptCount val="6"/>
                <c:pt idx="0">
                  <c:v>39966.696000000004</c:v>
                </c:pt>
                <c:pt idx="1">
                  <c:v>217699.63800000001</c:v>
                </c:pt>
                <c:pt idx="2">
                  <c:v>689946.40000000014</c:v>
                </c:pt>
                <c:pt idx="3">
                  <c:v>504972.7035</c:v>
                </c:pt>
                <c:pt idx="4">
                  <c:v>614614.52800000005</c:v>
                </c:pt>
                <c:pt idx="5">
                  <c:v>289057.544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9BE-484A-93AB-304FAACA27B8}"/>
            </c:ext>
          </c:extLst>
        </c:ser>
        <c:ser>
          <c:idx val="3"/>
          <c:order val="3"/>
          <c:tx>
            <c:strRef>
              <c:f>Sheet4!$B$7</c:f>
              <c:strCache>
                <c:ptCount val="1"/>
                <c:pt idx="0">
                  <c:v>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Sheet4!$C$3:$H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4!$C$7:$H$7</c:f>
              <c:numCache>
                <c:formatCode>General</c:formatCode>
                <c:ptCount val="6"/>
                <c:pt idx="0">
                  <c:v>24568.5825</c:v>
                </c:pt>
                <c:pt idx="1">
                  <c:v>288477.21000000002</c:v>
                </c:pt>
                <c:pt idx="2">
                  <c:v>226808.4</c:v>
                </c:pt>
                <c:pt idx="3">
                  <c:v>450325.87799999997</c:v>
                </c:pt>
                <c:pt idx="4">
                  <c:v>223653.076363636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99BE-484A-93AB-304FAACA27B8}"/>
            </c:ext>
          </c:extLst>
        </c:ser>
        <c:ser>
          <c:idx val="4"/>
          <c:order val="4"/>
          <c:tx>
            <c:strRef>
              <c:f>Sheet4!$B$8</c:f>
              <c:strCache>
                <c:ptCount val="1"/>
                <c:pt idx="0">
                  <c:v>5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Sheet4!$C$3:$H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4!$C$8:$H$8</c:f>
              <c:numCache>
                <c:formatCode>General</c:formatCode>
                <c:ptCount val="6"/>
                <c:pt idx="0">
                  <c:v>313286.82</c:v>
                </c:pt>
                <c:pt idx="1">
                  <c:v>201734.39999999999</c:v>
                </c:pt>
                <c:pt idx="2">
                  <c:v>1118476.8</c:v>
                </c:pt>
                <c:pt idx="3">
                  <c:v>453053.49000000005</c:v>
                </c:pt>
                <c:pt idx="4">
                  <c:v>360448.3636363635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99BE-484A-93AB-304FAACA27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09139320"/>
        <c:axId val="409139648"/>
      </c:scatterChart>
      <c:catAx>
        <c:axId val="445692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45686496"/>
        <c:crosses val="autoZero"/>
        <c:auto val="1"/>
        <c:lblAlgn val="ctr"/>
        <c:lblOffset val="100"/>
        <c:noMultiLvlLbl val="0"/>
      </c:catAx>
      <c:valAx>
        <c:axId val="445686496"/>
        <c:scaling>
          <c:orientation val="minMax"/>
          <c:max val="16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45692400"/>
        <c:crosses val="autoZero"/>
        <c:crossBetween val="between"/>
        <c:majorUnit val="400000"/>
        <c:dispUnits>
          <c:builtInUnit val="hundredThousands"/>
          <c:dispUnitsLbl>
            <c:layout>
              <c:manualLayout>
                <c:xMode val="edge"/>
                <c:yMode val="edge"/>
                <c:x val="2.6061487948660547E-2"/>
                <c:y val="0.38130299931833672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>
                      <a:effectLst/>
                    </a:rPr>
                    <a:t>10</a:t>
                  </a:r>
                  <a:r>
                    <a:rPr lang="de-AT" sz="1000" b="0" baseline="30000">
                      <a:effectLst/>
                    </a:rPr>
                    <a:t>5 </a:t>
                  </a:r>
                  <a:r>
                    <a:rPr lang="de-AT" sz="1000" b="0" i="0" u="none" strike="noStrike" baseline="0">
                      <a:effectLst/>
                    </a:rPr>
                    <a:t>cells</a:t>
                  </a:r>
                  <a:r>
                    <a:rPr lang="de-AT" sz="1000" b="0">
                      <a:effectLst/>
                    </a:rPr>
                    <a:t>/ml</a:t>
                  </a: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409139648"/>
        <c:scaling>
          <c:orientation val="minMax"/>
          <c:max val="1600000"/>
        </c:scaling>
        <c:delete val="1"/>
        <c:axPos val="r"/>
        <c:numFmt formatCode="General" sourceLinked="1"/>
        <c:majorTickMark val="out"/>
        <c:minorTickMark val="none"/>
        <c:tickLblPos val="nextTo"/>
        <c:crossAx val="409139320"/>
        <c:crosses val="max"/>
        <c:crossBetween val="midCat"/>
      </c:valAx>
      <c:valAx>
        <c:axId val="409139320"/>
        <c:scaling>
          <c:orientation val="minMax"/>
        </c:scaling>
        <c:delete val="1"/>
        <c:axPos val="t"/>
        <c:majorTickMark val="out"/>
        <c:minorTickMark val="none"/>
        <c:tickLblPos val="nextTo"/>
        <c:crossAx val="409139648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challenge control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Sheet4!$B$27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4!$C$21:$H$2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Sheet4!$C$27:$H$27</c:f>
              <c:numCache>
                <c:formatCode>General</c:formatCode>
                <c:ptCount val="6"/>
                <c:pt idx="0">
                  <c:v>174896.90117999999</c:v>
                </c:pt>
                <c:pt idx="1">
                  <c:v>332948.46400000004</c:v>
                </c:pt>
                <c:pt idx="2">
                  <c:v>47041.246199999994</c:v>
                </c:pt>
                <c:pt idx="3">
                  <c:v>102856.43599999999</c:v>
                </c:pt>
                <c:pt idx="4">
                  <c:v>225765.12299999999</c:v>
                </c:pt>
                <c:pt idx="5">
                  <c:v>332284.445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334-4BDD-AC3D-6BF83B5492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44055776"/>
        <c:axId val="444056104"/>
      </c:lineChart>
      <c:scatterChart>
        <c:scatterStyle val="lineMarker"/>
        <c:varyColors val="0"/>
        <c:ser>
          <c:idx val="0"/>
          <c:order val="0"/>
          <c:tx>
            <c:strRef>
              <c:f>Sheet4!$B$22</c:f>
              <c:strCache>
                <c:ptCount val="1"/>
                <c:pt idx="0">
                  <c:v>1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Sheet4!$C$21:$H$2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4!$C$22:$H$22</c:f>
              <c:numCache>
                <c:formatCode>General</c:formatCode>
                <c:ptCount val="6"/>
                <c:pt idx="0">
                  <c:v>245252</c:v>
                </c:pt>
                <c:pt idx="1">
                  <c:v>309792.45</c:v>
                </c:pt>
                <c:pt idx="2">
                  <c:v>35697.264999999992</c:v>
                </c:pt>
                <c:pt idx="3">
                  <c:v>92160.18</c:v>
                </c:pt>
                <c:pt idx="4">
                  <c:v>143260.95000000001</c:v>
                </c:pt>
                <c:pt idx="5">
                  <c:v>688728.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334-4BDD-AC3D-6BF83B5492B7}"/>
            </c:ext>
          </c:extLst>
        </c:ser>
        <c:ser>
          <c:idx val="1"/>
          <c:order val="1"/>
          <c:tx>
            <c:strRef>
              <c:f>Sheet4!$B$23</c:f>
              <c:strCache>
                <c:ptCount val="1"/>
                <c:pt idx="0">
                  <c:v>1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Sheet4!$C$21:$H$2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4!$C$23:$H$23</c:f>
              <c:numCache>
                <c:formatCode>General</c:formatCode>
                <c:ptCount val="6"/>
                <c:pt idx="0">
                  <c:v>26223.261899999998</c:v>
                </c:pt>
                <c:pt idx="1">
                  <c:v>523187.20000000001</c:v>
                </c:pt>
                <c:pt idx="2">
                  <c:v>102448.8</c:v>
                </c:pt>
                <c:pt idx="3">
                  <c:v>154132.99999999997</c:v>
                </c:pt>
                <c:pt idx="4">
                  <c:v>167252.24999999997</c:v>
                </c:pt>
                <c:pt idx="5">
                  <c:v>182753.415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334-4BDD-AC3D-6BF83B5492B7}"/>
            </c:ext>
          </c:extLst>
        </c:ser>
        <c:ser>
          <c:idx val="2"/>
          <c:order val="2"/>
          <c:tx>
            <c:strRef>
              <c:f>Sheet4!$B$24</c:f>
              <c:strCache>
                <c:ptCount val="1"/>
                <c:pt idx="0">
                  <c:v>1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Sheet4!$C$21:$H$2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4!$C$24:$H$24</c:f>
              <c:numCache>
                <c:formatCode>General</c:formatCode>
                <c:ptCount val="6"/>
                <c:pt idx="0">
                  <c:v>72304.770999999993</c:v>
                </c:pt>
                <c:pt idx="1">
                  <c:v>214239.06</c:v>
                </c:pt>
                <c:pt idx="2">
                  <c:v>30197.180000000004</c:v>
                </c:pt>
                <c:pt idx="3">
                  <c:v>96913.4</c:v>
                </c:pt>
                <c:pt idx="4">
                  <c:v>186339.6</c:v>
                </c:pt>
                <c:pt idx="5">
                  <c:v>125371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2334-4BDD-AC3D-6BF83B5492B7}"/>
            </c:ext>
          </c:extLst>
        </c:ser>
        <c:ser>
          <c:idx val="3"/>
          <c:order val="3"/>
          <c:tx>
            <c:strRef>
              <c:f>Sheet4!$B$25</c:f>
              <c:strCache>
                <c:ptCount val="1"/>
                <c:pt idx="0">
                  <c:v>1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Sheet4!$C$21:$H$2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4!$C$25:$H$25</c:f>
              <c:numCache>
                <c:formatCode>General</c:formatCode>
                <c:ptCount val="6"/>
                <c:pt idx="0">
                  <c:v>365939.14500000002</c:v>
                </c:pt>
                <c:pt idx="1">
                  <c:v>257388.89</c:v>
                </c:pt>
                <c:pt idx="2">
                  <c:v>28351.05</c:v>
                </c:pt>
                <c:pt idx="3">
                  <c:v>153907.79999999999</c:v>
                </c:pt>
                <c:pt idx="4">
                  <c:v>220125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2334-4BDD-AC3D-6BF83B5492B7}"/>
            </c:ext>
          </c:extLst>
        </c:ser>
        <c:ser>
          <c:idx val="4"/>
          <c:order val="4"/>
          <c:tx>
            <c:strRef>
              <c:f>Sheet4!$B$26</c:f>
              <c:strCache>
                <c:ptCount val="1"/>
                <c:pt idx="0">
                  <c:v>15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Sheet4!$C$21:$H$2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4!$C$26:$H$26</c:f>
              <c:numCache>
                <c:formatCode>General</c:formatCode>
                <c:ptCount val="6"/>
                <c:pt idx="0">
                  <c:v>164765.32799999998</c:v>
                </c:pt>
                <c:pt idx="1">
                  <c:v>360134.72</c:v>
                </c:pt>
                <c:pt idx="2">
                  <c:v>38511.936000000002</c:v>
                </c:pt>
                <c:pt idx="3">
                  <c:v>17167.8</c:v>
                </c:pt>
                <c:pt idx="4">
                  <c:v>411847.215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2334-4BDD-AC3D-6BF83B5492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8927104"/>
        <c:axId val="528926776"/>
      </c:scatterChart>
      <c:catAx>
        <c:axId val="4440557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44056104"/>
        <c:crosses val="autoZero"/>
        <c:auto val="1"/>
        <c:lblAlgn val="ctr"/>
        <c:lblOffset val="100"/>
        <c:noMultiLvlLbl val="0"/>
      </c:catAx>
      <c:valAx>
        <c:axId val="444056104"/>
        <c:scaling>
          <c:orientation val="minMax"/>
          <c:max val="16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44055776"/>
        <c:crosses val="autoZero"/>
        <c:crossBetween val="between"/>
        <c:majorUnit val="400000"/>
        <c:dispUnits>
          <c:builtInUnit val="hundredThousands"/>
          <c:dispUnitsLbl>
            <c:layout>
              <c:manualLayout>
                <c:xMode val="edge"/>
                <c:yMode val="edge"/>
                <c:x val="2.6061487948660547E-2"/>
                <c:y val="0.38130299931833672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>
                      <a:effectLst/>
                    </a:rPr>
                    <a:t>10</a:t>
                  </a:r>
                  <a:r>
                    <a:rPr lang="de-AT" sz="1000" b="0" baseline="30000">
                      <a:effectLst/>
                    </a:rPr>
                    <a:t>5 </a:t>
                  </a:r>
                  <a:r>
                    <a:rPr lang="de-AT" sz="1000" b="0" i="0" u="none" strike="noStrike" baseline="0">
                      <a:effectLst/>
                    </a:rPr>
                    <a:t>cells</a:t>
                  </a:r>
                  <a:r>
                    <a:rPr lang="de-AT" sz="1000" b="0">
                      <a:effectLst/>
                    </a:rPr>
                    <a:t>/ml</a:t>
                  </a: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528926776"/>
        <c:scaling>
          <c:orientation val="minMax"/>
          <c:max val="1600000"/>
        </c:scaling>
        <c:delete val="1"/>
        <c:axPos val="r"/>
        <c:numFmt formatCode="General" sourceLinked="1"/>
        <c:majorTickMark val="out"/>
        <c:minorTickMark val="none"/>
        <c:tickLblPos val="nextTo"/>
        <c:crossAx val="528927104"/>
        <c:crosses val="max"/>
        <c:crossBetween val="midCat"/>
      </c:valAx>
      <c:valAx>
        <c:axId val="528927104"/>
        <c:scaling>
          <c:orientation val="minMax"/>
        </c:scaling>
        <c:delete val="1"/>
        <c:axPos val="t"/>
        <c:majorTickMark val="out"/>
        <c:minorTickMark val="none"/>
        <c:tickLblPos val="nextTo"/>
        <c:crossAx val="528926776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vaccinated/challenged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Sheet4!$B$36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4!$C$30:$G$30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cat>
          <c:val>
            <c:numRef>
              <c:f>Sheet4!$C$36:$G$36</c:f>
              <c:numCache>
                <c:formatCode>General</c:formatCode>
                <c:ptCount val="5"/>
                <c:pt idx="0">
                  <c:v>690299.93900000001</c:v>
                </c:pt>
                <c:pt idx="1">
                  <c:v>232376.39440000002</c:v>
                </c:pt>
                <c:pt idx="2">
                  <c:v>200119.065</c:v>
                </c:pt>
                <c:pt idx="3">
                  <c:v>524708.77359999996</c:v>
                </c:pt>
                <c:pt idx="4">
                  <c:v>346052.710000000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C69-4FE2-BF4D-565327AC9F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7184344"/>
        <c:axId val="507184672"/>
      </c:lineChart>
      <c:scatterChart>
        <c:scatterStyle val="lineMarker"/>
        <c:varyColors val="0"/>
        <c:ser>
          <c:idx val="0"/>
          <c:order val="0"/>
          <c:tx>
            <c:strRef>
              <c:f>Sheet4!$B$31</c:f>
              <c:strCache>
                <c:ptCount val="1"/>
                <c:pt idx="0">
                  <c:v>16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Sheet4!$C$30:$G$30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Sheet4!$C$31:$G$31</c:f>
              <c:numCache>
                <c:formatCode>General</c:formatCode>
                <c:ptCount val="5"/>
                <c:pt idx="0">
                  <c:v>263515.56</c:v>
                </c:pt>
                <c:pt idx="1">
                  <c:v>135792</c:v>
                </c:pt>
                <c:pt idx="2">
                  <c:v>146249.31999999998</c:v>
                </c:pt>
                <c:pt idx="3">
                  <c:v>42868.847999999998</c:v>
                </c:pt>
                <c:pt idx="4">
                  <c:v>425104.400000000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C69-4FE2-BF4D-565327AC9F1F}"/>
            </c:ext>
          </c:extLst>
        </c:ser>
        <c:ser>
          <c:idx val="1"/>
          <c:order val="1"/>
          <c:tx>
            <c:strRef>
              <c:f>Sheet4!$B$32</c:f>
              <c:strCache>
                <c:ptCount val="1"/>
                <c:pt idx="0">
                  <c:v>17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Sheet4!$C$30:$G$30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Sheet4!$C$32:$G$32</c:f>
              <c:numCache>
                <c:formatCode>General</c:formatCode>
                <c:ptCount val="5"/>
                <c:pt idx="0">
                  <c:v>740766.28500000003</c:v>
                </c:pt>
                <c:pt idx="1">
                  <c:v>545836.31999999995</c:v>
                </c:pt>
                <c:pt idx="2">
                  <c:v>119443.617</c:v>
                </c:pt>
                <c:pt idx="3">
                  <c:v>345633.75</c:v>
                </c:pt>
                <c:pt idx="4">
                  <c:v>267001.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C69-4FE2-BF4D-565327AC9F1F}"/>
            </c:ext>
          </c:extLst>
        </c:ser>
        <c:ser>
          <c:idx val="2"/>
          <c:order val="2"/>
          <c:tx>
            <c:strRef>
              <c:f>Sheet4!$B$33</c:f>
              <c:strCache>
                <c:ptCount val="1"/>
                <c:pt idx="0">
                  <c:v>18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Sheet4!$C$30:$G$30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Sheet4!$C$33:$G$33</c:f>
              <c:numCache>
                <c:formatCode>General</c:formatCode>
                <c:ptCount val="5"/>
                <c:pt idx="0">
                  <c:v>518939.4</c:v>
                </c:pt>
                <c:pt idx="1">
                  <c:v>226983.9</c:v>
                </c:pt>
                <c:pt idx="2">
                  <c:v>56495.88</c:v>
                </c:pt>
                <c:pt idx="3">
                  <c:v>388793.4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C69-4FE2-BF4D-565327AC9F1F}"/>
            </c:ext>
          </c:extLst>
        </c:ser>
        <c:ser>
          <c:idx val="3"/>
          <c:order val="3"/>
          <c:tx>
            <c:strRef>
              <c:f>Sheet4!$B$34</c:f>
              <c:strCache>
                <c:ptCount val="1"/>
                <c:pt idx="0">
                  <c:v>19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Sheet4!$C$30:$G$30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Sheet4!$C$34:$G$34</c:f>
              <c:numCache>
                <c:formatCode>General</c:formatCode>
                <c:ptCount val="5"/>
                <c:pt idx="0">
                  <c:v>487615.05000000005</c:v>
                </c:pt>
                <c:pt idx="1">
                  <c:v>206528.84</c:v>
                </c:pt>
                <c:pt idx="2">
                  <c:v>157428.008</c:v>
                </c:pt>
                <c:pt idx="3">
                  <c:v>1025173.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4C69-4FE2-BF4D-565327AC9F1F}"/>
            </c:ext>
          </c:extLst>
        </c:ser>
        <c:ser>
          <c:idx val="4"/>
          <c:order val="4"/>
          <c:tx>
            <c:strRef>
              <c:f>Sheet4!$B$35</c:f>
              <c:strCache>
                <c:ptCount val="1"/>
                <c:pt idx="0">
                  <c:v>2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Sheet4!$C$30:$G$30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Sheet4!$C$35:$G$35</c:f>
              <c:numCache>
                <c:formatCode>General</c:formatCode>
                <c:ptCount val="5"/>
                <c:pt idx="0">
                  <c:v>1440663.4</c:v>
                </c:pt>
                <c:pt idx="1">
                  <c:v>46740.912000000004</c:v>
                </c:pt>
                <c:pt idx="2">
                  <c:v>520978.5</c:v>
                </c:pt>
                <c:pt idx="3">
                  <c:v>821074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4C69-4FE2-BF4D-565327AC9F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3193184"/>
        <c:axId val="523192856"/>
      </c:scatterChart>
      <c:catAx>
        <c:axId val="5071843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07184672"/>
        <c:crosses val="autoZero"/>
        <c:auto val="1"/>
        <c:lblAlgn val="ctr"/>
        <c:lblOffset val="100"/>
        <c:noMultiLvlLbl val="0"/>
      </c:catAx>
      <c:valAx>
        <c:axId val="507184672"/>
        <c:scaling>
          <c:orientation val="minMax"/>
          <c:max val="16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07184344"/>
        <c:crosses val="autoZero"/>
        <c:crossBetween val="between"/>
        <c:majorUnit val="400000"/>
        <c:dispUnits>
          <c:builtInUnit val="hundredThousands"/>
          <c:dispUnitsLbl>
            <c:layout>
              <c:manualLayout>
                <c:xMode val="edge"/>
                <c:yMode val="edge"/>
                <c:x val="2.8430714125811506E-2"/>
                <c:y val="0.38130299931833672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>
                      <a:effectLst/>
                    </a:rPr>
                    <a:t>10</a:t>
                  </a:r>
                  <a:r>
                    <a:rPr lang="de-AT" sz="1000" b="0" baseline="30000">
                      <a:effectLst/>
                    </a:rPr>
                    <a:t>5 </a:t>
                  </a:r>
                  <a:r>
                    <a:rPr lang="de-AT" sz="1000" b="0" i="0" u="none" strike="noStrike" baseline="0">
                      <a:effectLst/>
                    </a:rPr>
                    <a:t>cells</a:t>
                  </a:r>
                  <a:r>
                    <a:rPr lang="de-AT" sz="1000" b="0">
                      <a:effectLst/>
                    </a:rPr>
                    <a:t>/ml</a:t>
                  </a: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523192856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523193184"/>
        <c:crosses val="max"/>
        <c:crossBetween val="midCat"/>
      </c:valAx>
      <c:valAx>
        <c:axId val="523193184"/>
        <c:scaling>
          <c:orientation val="minMax"/>
        </c:scaling>
        <c:delete val="1"/>
        <c:axPos val="t"/>
        <c:majorTickMark val="out"/>
        <c:minorTickMark val="none"/>
        <c:tickLblPos val="nextTo"/>
        <c:crossAx val="523192856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4629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5253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7402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678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190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3703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3198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7089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9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0548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4932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6703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37393" y="181408"/>
            <a:ext cx="11520062" cy="6313323"/>
            <a:chOff x="337393" y="181408"/>
            <a:chExt cx="11520062" cy="6313323"/>
          </a:xfrm>
        </p:grpSpPr>
        <p:grpSp>
          <p:nvGrpSpPr>
            <p:cNvPr id="2" name="Group 1"/>
            <p:cNvGrpSpPr/>
            <p:nvPr/>
          </p:nvGrpSpPr>
          <p:grpSpPr>
            <a:xfrm>
              <a:off x="337393" y="181408"/>
              <a:ext cx="11520062" cy="6313323"/>
              <a:chOff x="337393" y="181408"/>
              <a:chExt cx="11520062" cy="6313323"/>
            </a:xfrm>
          </p:grpSpPr>
          <p:graphicFrame>
            <p:nvGraphicFramePr>
              <p:cNvPr id="20" name="Chart 19"/>
              <p:cNvGraphicFramePr/>
              <p:nvPr>
                <p:extLst>
                  <p:ext uri="{D42A27DB-BD31-4B8C-83A1-F6EECF244321}">
                    <p14:modId xmlns:p14="http://schemas.microsoft.com/office/powerpoint/2010/main" val="1901196747"/>
                  </p:ext>
                </p:extLst>
              </p:nvPr>
            </p:nvGraphicFramePr>
            <p:xfrm>
              <a:off x="6497055" y="208154"/>
              <a:ext cx="5360400" cy="293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8" name="TextBox 7"/>
              <p:cNvSpPr txBox="1"/>
              <p:nvPr/>
            </p:nvSpPr>
            <p:spPr>
              <a:xfrm>
                <a:off x="337393" y="181408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/>
                  <a:t>A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6185622" y="181408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B</a:t>
                </a:r>
                <a:endParaRPr lang="en-GB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37393" y="3560731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C</a:t>
                </a:r>
                <a:endParaRPr lang="en-GB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6185622" y="3560731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D</a:t>
                </a:r>
                <a:endParaRPr lang="en-GB" dirty="0"/>
              </a:p>
            </p:txBody>
          </p:sp>
          <p:graphicFrame>
            <p:nvGraphicFramePr>
              <p:cNvPr id="19" name="Chart 18"/>
              <p:cNvGraphicFramePr/>
              <p:nvPr>
                <p:extLst>
                  <p:ext uri="{D42A27DB-BD31-4B8C-83A1-F6EECF244321}">
                    <p14:modId xmlns:p14="http://schemas.microsoft.com/office/powerpoint/2010/main" val="869692958"/>
                  </p:ext>
                </p:extLst>
              </p:nvPr>
            </p:nvGraphicFramePr>
            <p:xfrm>
              <a:off x="407829" y="208154"/>
              <a:ext cx="5360400" cy="293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21" name="Chart 20"/>
              <p:cNvGraphicFramePr/>
              <p:nvPr>
                <p:extLst>
                  <p:ext uri="{D42A27DB-BD31-4B8C-83A1-F6EECF244321}">
                    <p14:modId xmlns:p14="http://schemas.microsoft.com/office/powerpoint/2010/main" val="555984058"/>
                  </p:ext>
                </p:extLst>
              </p:nvPr>
            </p:nvGraphicFramePr>
            <p:xfrm>
              <a:off x="407829" y="3560731"/>
              <a:ext cx="5360400" cy="293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22" name="Chart 21"/>
              <p:cNvGraphicFramePr/>
              <p:nvPr>
                <p:extLst>
                  <p:ext uri="{D42A27DB-BD31-4B8C-83A1-F6EECF244321}">
                    <p14:modId xmlns:p14="http://schemas.microsoft.com/office/powerpoint/2010/main" val="2417550359"/>
                  </p:ext>
                </p:extLst>
              </p:nvPr>
            </p:nvGraphicFramePr>
            <p:xfrm>
              <a:off x="6497055" y="3560731"/>
              <a:ext cx="5360400" cy="293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</p:grpSp>
        <p:sp>
          <p:nvSpPr>
            <p:cNvPr id="14" name="TextBox 13"/>
            <p:cNvSpPr txBox="1"/>
            <p:nvPr/>
          </p:nvSpPr>
          <p:spPr>
            <a:xfrm>
              <a:off x="2831856" y="5531128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376450" y="5168820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593634" y="5481700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795548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Company>Vetmeduni Vien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 Luca Carlotta</dc:creator>
  <cp:lastModifiedBy>De Luca Carlotta</cp:lastModifiedBy>
  <cp:revision>11</cp:revision>
  <dcterms:created xsi:type="dcterms:W3CDTF">2020-07-30T11:05:44Z</dcterms:created>
  <dcterms:modified xsi:type="dcterms:W3CDTF">2020-07-30T12:20:46Z</dcterms:modified>
</cp:coreProperties>
</file>